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6"/>
  </p:notesMasterIdLst>
  <p:sldIdLst>
    <p:sldId id="259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97" d="100"/>
          <a:sy n="97" d="100"/>
        </p:scale>
        <p:origin x="78" y="3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8D63C8F-D10D-4583-8B33-F1649C7CC9D6}" type="datetimeFigureOut">
              <a:rPr lang="en-US" smtClean="0"/>
              <a:t>7/2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44DABBD-873B-4D93-8B2F-A2EB7DD149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58582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Figure Caption. Individual responses for the C_CMR score and corresponding individual’s response for each component that comprises the C_CMR score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36BDAFE-E6C8-4EBA-A01A-714A9B902A5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47082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72B2B-8322-4558-93C6-0A17477A2A16}" type="datetimeFigureOut">
              <a:rPr lang="en-US" smtClean="0"/>
              <a:t>7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DA82A-1216-4EEE-BCED-7F8E49406E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39862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72B2B-8322-4558-93C6-0A17477A2A16}" type="datetimeFigureOut">
              <a:rPr lang="en-US" smtClean="0"/>
              <a:t>7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DA82A-1216-4EEE-BCED-7F8E49406E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67558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72B2B-8322-4558-93C6-0A17477A2A16}" type="datetimeFigureOut">
              <a:rPr lang="en-US" smtClean="0"/>
              <a:t>7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DA82A-1216-4EEE-BCED-7F8E49406E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37968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72B2B-8322-4558-93C6-0A17477A2A16}" type="datetimeFigureOut">
              <a:rPr lang="en-US" smtClean="0"/>
              <a:t>7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DA82A-1216-4EEE-BCED-7F8E49406E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63939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72B2B-8322-4558-93C6-0A17477A2A16}" type="datetimeFigureOut">
              <a:rPr lang="en-US" smtClean="0"/>
              <a:t>7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DA82A-1216-4EEE-BCED-7F8E49406E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84053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72B2B-8322-4558-93C6-0A17477A2A16}" type="datetimeFigureOut">
              <a:rPr lang="en-US" smtClean="0"/>
              <a:t>7/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DA82A-1216-4EEE-BCED-7F8E49406E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40182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72B2B-8322-4558-93C6-0A17477A2A16}" type="datetimeFigureOut">
              <a:rPr lang="en-US" smtClean="0"/>
              <a:t>7/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DA82A-1216-4EEE-BCED-7F8E49406E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89999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72B2B-8322-4558-93C6-0A17477A2A16}" type="datetimeFigureOut">
              <a:rPr lang="en-US" smtClean="0"/>
              <a:t>7/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DA82A-1216-4EEE-BCED-7F8E49406E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13289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72B2B-8322-4558-93C6-0A17477A2A16}" type="datetimeFigureOut">
              <a:rPr lang="en-US" smtClean="0"/>
              <a:t>7/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DA82A-1216-4EEE-BCED-7F8E49406E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38971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72B2B-8322-4558-93C6-0A17477A2A16}" type="datetimeFigureOut">
              <a:rPr lang="en-US" smtClean="0"/>
              <a:t>7/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DA82A-1216-4EEE-BCED-7F8E49406E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06017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72B2B-8322-4558-93C6-0A17477A2A16}" type="datetimeFigureOut">
              <a:rPr lang="en-US" smtClean="0"/>
              <a:t>7/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DA82A-1216-4EEE-BCED-7F8E49406E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15152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072B2B-8322-4558-93C6-0A17477A2A16}" type="datetimeFigureOut">
              <a:rPr lang="en-US" smtClean="0"/>
              <a:t>7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6DA82A-1216-4EEE-BCED-7F8E49406E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40619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Box 20">
            <a:extLst>
              <a:ext uri="{FF2B5EF4-FFF2-40B4-BE49-F238E27FC236}">
                <a16:creationId xmlns:a16="http://schemas.microsoft.com/office/drawing/2014/main" id="{BC7A0281-C290-4F71-BCF8-5A9DDDC9ACAE}"/>
              </a:ext>
            </a:extLst>
          </p:cNvPr>
          <p:cNvSpPr txBox="1"/>
          <p:nvPr/>
        </p:nvSpPr>
        <p:spPr>
          <a:xfrm>
            <a:off x="1888093" y="-1863"/>
            <a:ext cx="5084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ED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2522027-2094-4E7C-BBC1-7D3E632FBFDE}"/>
              </a:ext>
            </a:extLst>
          </p:cNvPr>
          <p:cNvSpPr txBox="1"/>
          <p:nvPr/>
        </p:nvSpPr>
        <p:spPr>
          <a:xfrm>
            <a:off x="4754382" y="-1863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WL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C1E248C-1D47-4ED5-AD1D-3400228E1B27}"/>
              </a:ext>
            </a:extLst>
          </p:cNvPr>
          <p:cNvSpPr txBox="1"/>
          <p:nvPr/>
        </p:nvSpPr>
        <p:spPr>
          <a:xfrm>
            <a:off x="7521234" y="-1863"/>
            <a:ext cx="7200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WL+EX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C67C2BC-4E02-41AC-A381-29FBCE474B36}"/>
              </a:ext>
            </a:extLst>
          </p:cNvPr>
          <p:cNvSpPr txBox="1"/>
          <p:nvPr/>
        </p:nvSpPr>
        <p:spPr>
          <a:xfrm>
            <a:off x="91609" y="1018663"/>
            <a:ext cx="57900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∆ WC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0C8AB8CA-B6AD-41F3-AC3A-65DC115DA4CF}"/>
              </a:ext>
            </a:extLst>
          </p:cNvPr>
          <p:cNvSpPr txBox="1"/>
          <p:nvPr/>
        </p:nvSpPr>
        <p:spPr>
          <a:xfrm>
            <a:off x="96281" y="5072698"/>
            <a:ext cx="53457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∆ TG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</a:p>
        </p:txBody>
      </p:sp>
      <p:pic>
        <p:nvPicPr>
          <p:cNvPr id="3" name="Picture 2" descr="A close up of a logo&#10;&#10;Description automatically generated">
            <a:extLst>
              <a:ext uri="{FF2B5EF4-FFF2-40B4-BE49-F238E27FC236}">
                <a16:creationId xmlns:a16="http://schemas.microsoft.com/office/drawing/2014/main" id="{A8302C00-B20A-4408-AF9B-3169B16F7D0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0926" y="396780"/>
            <a:ext cx="2786113" cy="1975275"/>
          </a:xfrm>
          <a:prstGeom prst="rect">
            <a:avLst/>
          </a:prstGeom>
        </p:spPr>
      </p:pic>
      <p:pic>
        <p:nvPicPr>
          <p:cNvPr id="6" name="Picture 5" descr="A close up of a logo&#10;&#10;Description automatically generated">
            <a:extLst>
              <a:ext uri="{FF2B5EF4-FFF2-40B4-BE49-F238E27FC236}">
                <a16:creationId xmlns:a16="http://schemas.microsoft.com/office/drawing/2014/main" id="{021F20E3-536D-4C0E-AFC5-47BEAB6011E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6646" y="2482532"/>
            <a:ext cx="2786113" cy="1975275"/>
          </a:xfrm>
          <a:prstGeom prst="rect">
            <a:avLst/>
          </a:prstGeom>
        </p:spPr>
      </p:pic>
      <p:pic>
        <p:nvPicPr>
          <p:cNvPr id="17" name="Picture 16" descr="A close up of a logo&#10;&#10;Description automatically generated">
            <a:extLst>
              <a:ext uri="{FF2B5EF4-FFF2-40B4-BE49-F238E27FC236}">
                <a16:creationId xmlns:a16="http://schemas.microsoft.com/office/drawing/2014/main" id="{375C4A45-661A-4C1F-9A5D-1CDB31C7856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9214" y="4568284"/>
            <a:ext cx="2786113" cy="1975275"/>
          </a:xfrm>
          <a:prstGeom prst="rect">
            <a:avLst/>
          </a:prstGeom>
        </p:spPr>
      </p:pic>
      <p:pic>
        <p:nvPicPr>
          <p:cNvPr id="24" name="Picture 23" descr="A picture containing table&#10;&#10;Description automatically generated">
            <a:extLst>
              <a:ext uri="{FF2B5EF4-FFF2-40B4-BE49-F238E27FC236}">
                <a16:creationId xmlns:a16="http://schemas.microsoft.com/office/drawing/2014/main" id="{3EC945CC-A3DE-4373-A54B-4D365B54AF10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7455" y="401655"/>
            <a:ext cx="2786113" cy="1975275"/>
          </a:xfrm>
          <a:prstGeom prst="rect">
            <a:avLst/>
          </a:prstGeom>
        </p:spPr>
      </p:pic>
      <p:pic>
        <p:nvPicPr>
          <p:cNvPr id="29" name="Picture 28" descr="A close up of a logo&#10;&#10;Description automatically generated">
            <a:extLst>
              <a:ext uri="{FF2B5EF4-FFF2-40B4-BE49-F238E27FC236}">
                <a16:creationId xmlns:a16="http://schemas.microsoft.com/office/drawing/2014/main" id="{A15D6B27-1F19-44EF-BD70-A89FB6F57C3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34212" y="2482532"/>
            <a:ext cx="2792210" cy="1975275"/>
          </a:xfrm>
          <a:prstGeom prst="rect">
            <a:avLst/>
          </a:prstGeom>
        </p:spPr>
      </p:pic>
      <p:pic>
        <p:nvPicPr>
          <p:cNvPr id="31" name="Picture 30" descr="A picture containing clock&#10;&#10;Description automatically generated">
            <a:extLst>
              <a:ext uri="{FF2B5EF4-FFF2-40B4-BE49-F238E27FC236}">
                <a16:creationId xmlns:a16="http://schemas.microsoft.com/office/drawing/2014/main" id="{B3CE5DEE-33C1-4994-B7CD-F6C64F48D0CA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34212" y="4573206"/>
            <a:ext cx="2792210" cy="1975275"/>
          </a:xfrm>
          <a:prstGeom prst="rect">
            <a:avLst/>
          </a:prstGeom>
        </p:spPr>
      </p:pic>
      <p:pic>
        <p:nvPicPr>
          <p:cNvPr id="33" name="Picture 32" descr="A close up of a logo&#10;&#10;Description automatically generated">
            <a:extLst>
              <a:ext uri="{FF2B5EF4-FFF2-40B4-BE49-F238E27FC236}">
                <a16:creationId xmlns:a16="http://schemas.microsoft.com/office/drawing/2014/main" id="{42A72EAB-61FF-4ADB-9067-11ADD35508C2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48834" y="396778"/>
            <a:ext cx="2786113" cy="1975275"/>
          </a:xfrm>
          <a:prstGeom prst="rect">
            <a:avLst/>
          </a:prstGeom>
        </p:spPr>
      </p:pic>
      <p:pic>
        <p:nvPicPr>
          <p:cNvPr id="35" name="Picture 34" descr="A picture containing table&#10;&#10;Description automatically generated">
            <a:extLst>
              <a:ext uri="{FF2B5EF4-FFF2-40B4-BE49-F238E27FC236}">
                <a16:creationId xmlns:a16="http://schemas.microsoft.com/office/drawing/2014/main" id="{E7DF606E-EAC8-4D12-8DB9-775FDA8B73DF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57887" y="2482531"/>
            <a:ext cx="2786113" cy="1975275"/>
          </a:xfrm>
          <a:prstGeom prst="rect">
            <a:avLst/>
          </a:prstGeom>
        </p:spPr>
      </p:pic>
      <p:pic>
        <p:nvPicPr>
          <p:cNvPr id="39" name="Picture 38" descr="A close up of a logo&#10;&#10;Description automatically generated">
            <a:extLst>
              <a:ext uri="{FF2B5EF4-FFF2-40B4-BE49-F238E27FC236}">
                <a16:creationId xmlns:a16="http://schemas.microsoft.com/office/drawing/2014/main" id="{F9FC4FA2-0F0A-4ADA-BEF5-CE7A07164392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46006" y="4568284"/>
            <a:ext cx="2786113" cy="1975275"/>
          </a:xfrm>
          <a:prstGeom prst="rect">
            <a:avLst/>
          </a:prstGeom>
        </p:spPr>
      </p:pic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C6EC1347-5B28-42DE-B9F2-EB14F97838CC}"/>
              </a:ext>
            </a:extLst>
          </p:cNvPr>
          <p:cNvCxnSpPr>
            <a:cxnSpLocks/>
          </p:cNvCxnSpPr>
          <p:nvPr/>
        </p:nvCxnSpPr>
        <p:spPr>
          <a:xfrm>
            <a:off x="3547662" y="390409"/>
            <a:ext cx="9793" cy="6057044"/>
          </a:xfrm>
          <a:prstGeom prst="line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041E09D8-1E6E-4317-BF0D-67E6813F1028}"/>
              </a:ext>
            </a:extLst>
          </p:cNvPr>
          <p:cNvCxnSpPr>
            <a:cxnSpLocks/>
          </p:cNvCxnSpPr>
          <p:nvPr/>
        </p:nvCxnSpPr>
        <p:spPr>
          <a:xfrm>
            <a:off x="6353360" y="396780"/>
            <a:ext cx="4527" cy="6050673"/>
          </a:xfrm>
          <a:prstGeom prst="line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9A81AF76-5857-4658-8513-D498EB1D8BCA}"/>
              </a:ext>
            </a:extLst>
          </p:cNvPr>
          <p:cNvSpPr txBox="1"/>
          <p:nvPr/>
        </p:nvSpPr>
        <p:spPr>
          <a:xfrm>
            <a:off x="-54810" y="3068290"/>
            <a:ext cx="93006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∆ Glucose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7E6A5711-9178-4E5B-A8A5-DF886FF95A9F}"/>
              </a:ext>
            </a:extLst>
          </p:cNvPr>
          <p:cNvSpPr/>
          <p:nvPr/>
        </p:nvSpPr>
        <p:spPr>
          <a:xfrm>
            <a:off x="-54810" y="6441411"/>
            <a:ext cx="9400904" cy="415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5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2.</a:t>
            </a:r>
            <a:r>
              <a:rPr lang="en-US" sz="105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Individual responses for the components of the C_CMR score and corresponding individual’s response for each component that comprises the C_CMR score. </a:t>
            </a:r>
            <a:r>
              <a:rPr lang="en-US" sz="105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Participant responses are in the same order for each variable. For example, the first bar in each graph for a given group is the same individual.</a:t>
            </a:r>
            <a:endParaRPr lang="en-US" sz="105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867308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8F69336024EC64E82E6F5A5D4BCDEE9" ma:contentTypeVersion="10" ma:contentTypeDescription="Create a new document." ma:contentTypeScope="" ma:versionID="50fd714c79b4dee053927e8a29b435f1">
  <xsd:schema xmlns:xsd="http://www.w3.org/2001/XMLSchema" xmlns:xs="http://www.w3.org/2001/XMLSchema" xmlns:p="http://schemas.microsoft.com/office/2006/metadata/properties" xmlns:ns3="303f90ee-307c-406a-87d8-022e29923cee" xmlns:ns4="4f82b324-42d0-44de-ad8d-71310ebc2d18" targetNamespace="http://schemas.microsoft.com/office/2006/metadata/properties" ma:root="true" ma:fieldsID="db0574edcd5eb09cdfee18d846f82535" ns3:_="" ns4:_="">
    <xsd:import namespace="303f90ee-307c-406a-87d8-022e29923cee"/>
    <xsd:import namespace="4f82b324-42d0-44de-ad8d-71310ebc2d18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Tags" minOccurs="0"/>
                <xsd:element ref="ns3:MediaServiceGenerationTime" minOccurs="0"/>
                <xsd:element ref="ns3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03f90ee-307c-406a-87d8-022e29923ce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5" nillable="true" ma:displayName="Tags" ma:internalName="MediaServiceAutoTags" ma:readOnly="true">
      <xsd:simpleType>
        <xsd:restriction base="dms:Text"/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f82b324-42d0-44de-ad8d-71310ebc2d18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4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6CBA30D0-A787-46ED-903C-2E71DA45302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303f90ee-307c-406a-87d8-022e29923cee"/>
    <ds:schemaRef ds:uri="4f82b324-42d0-44de-ad8d-71310ebc2d18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B15B5962-E083-472F-9543-9748567C9E51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E485973A-F3E8-4AC8-9827-09FE43985DE3}">
  <ds:schemaRefs>
    <ds:schemaRef ds:uri="http://purl.org/dc/dcmitype/"/>
    <ds:schemaRef ds:uri="http://schemas.microsoft.com/office/2006/metadata/properties"/>
    <ds:schemaRef ds:uri="http://schemas.microsoft.com/office/infopath/2007/PartnerControls"/>
    <ds:schemaRef ds:uri="http://schemas.microsoft.com/office/2006/documentManagement/types"/>
    <ds:schemaRef ds:uri="http://schemas.openxmlformats.org/package/2006/metadata/core-properties"/>
    <ds:schemaRef ds:uri="4f82b324-42d0-44de-ad8d-71310ebc2d18"/>
    <ds:schemaRef ds:uri="http://www.w3.org/XML/1998/namespace"/>
    <ds:schemaRef ds:uri="303f90ee-307c-406a-87d8-022e29923cee"/>
    <ds:schemaRef ds:uri="http://purl.org/dc/terms/"/>
    <ds:schemaRef ds:uri="http://purl.org/dc/elements/1.1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100</Words>
  <Application>Microsoft Office PowerPoint</Application>
  <PresentationFormat>On-screen Show (4:3)</PresentationFormat>
  <Paragraphs>1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ENNAN, Andrea</dc:creator>
  <cp:lastModifiedBy>BRENNAN, Andrea</cp:lastModifiedBy>
  <cp:revision>3</cp:revision>
  <dcterms:created xsi:type="dcterms:W3CDTF">2020-05-26T23:57:33Z</dcterms:created>
  <dcterms:modified xsi:type="dcterms:W3CDTF">2020-07-02T17:41:0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8F69336024EC64E82E6F5A5D4BCDEE9</vt:lpwstr>
  </property>
</Properties>
</file>